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FE532-20C6-4431-9D24-E48307E244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68FF2-7682-4054-BCE0-971474FE4A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C17A5-6559-41C9-8BB0-3B217A06C4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856745-00CC-45E8-AFDD-8C500A1F29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9883B1-DDBA-4590-97EF-289E1E7339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8BB9A9-CF7D-4226-98F6-2CC01D5172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74BFBF-8333-47F0-8DCA-AAFA21908A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6102A0-FBB0-48E1-B139-2917D2ABBE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161F2E-2AA3-4865-A51F-A98058844E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9FB09-D5DE-4BC0-BF77-C0788D826C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80CC6-4089-420F-9BDB-6C52EDA131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614784-446A-4295-95A6-962D64DC6D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5FBD82-3B45-4C36-867A-39849469CFD9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179280" y="5513400"/>
            <a:ext cx="88934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S3 Fig. Migration position of N-WASP and Integrin-</a:t>
            </a:r>
            <a:r>
              <a:rPr b="1" lang="de-DE" sz="14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V in Western blot analysis.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Western blotting analysis of lysates of MDA-MB-468 cells subjected to miR-142-3p upregulation (miR-142-3p) and inhibition (anti-miR-142-3p) was performed as described in Figure 3f of the main manuscript. Mr indicates the migration position of molecular weight markers (Thermo Scientific PAGE ruler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538200" y="476280"/>
            <a:ext cx="8175600" cy="406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05T06:18:10Z</dcterms:created>
  <dc:creator>Martin Götte</dc:creator>
  <dc:description/>
  <dc:language>en-US</dc:language>
  <cp:lastModifiedBy>Prof. Dr. Martin Götte</cp:lastModifiedBy>
  <dcterms:modified xsi:type="dcterms:W3CDTF">2015-11-16T14:52:21Z</dcterms:modified>
  <cp:revision>11</cp:revision>
  <dc:subject/>
  <dc:title>Folie 1</dc:title>
</cp:coreProperties>
</file>